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620"/>
    <p:restoredTop sz="94630"/>
  </p:normalViewPr>
  <p:slideViewPr>
    <p:cSldViewPr snapToGrid="0" snapToObjects="1">
      <p:cViewPr varScale="1">
        <p:scale>
          <a:sx n="86" d="100"/>
          <a:sy n="86" d="100"/>
        </p:scale>
        <p:origin x="523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99E0D-B8C5-5841-A0FB-8FDC1F0136E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CBD605B2-CDBE-FC40-BF38-A609A37B73F7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9AAD2D0-34FC-1A45-8E9B-73AE30BE31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2ED048-E4E4-A943-BBB8-59653546F98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E2CF0C-D93A-3A45-B443-C6187462AE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493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81F19A2-1F0B-504E-B7F9-90356B40884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388A8B6-E557-934C-B86E-40555E54BB2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2F5ADF-AC6D-FE48-AE85-DC5AD69295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85BB4C8-8AB7-0949-96D3-9BDB8358F8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7EE279C-4E71-0F44-830A-B9A2F0453F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130898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5A8E3F68-66B6-6A47-B77D-B4AA197CD7C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1D95678-B14F-4645-B850-3CA4FD6ACE5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C7E6637-6481-E14D-A42B-B2805155AF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51DB147-A602-5F4A-B806-F8290928714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D848CFC-3425-754F-90D6-B54987E1D55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18247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6856DC-BD09-DD49-8442-200D4D6AF0F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2E742B8-F294-6A49-8CE4-72372C7F09BE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A9F0546-4355-2644-ACDF-518869DB36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B13530-EDFF-8E4F-94D0-E1496E034F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A30E1E7-DCA8-3D41-B8E5-5F5F07D85C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9045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8BA85F-B267-FF4A-AF8B-8CF6CAC22EA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6068733-C3B7-9B4B-9944-19D1A8EA126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450487A-B420-964C-AC74-7A1210E6BD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C0C968-B20C-BE43-AD4A-DAE7FDBEDE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FC2D7B0-7B55-4445-BB06-EA7895F6DC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680639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9DCBF44-8A05-0B42-BE43-D54062374D0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5F45903-4C22-9744-BF2D-4989B3DE8EE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770CA32-17A2-A742-88D6-887948AC901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6F507C1-C698-0449-83BA-A19DF0413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C5875F2-4409-E64E-8F5B-C0222E2106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0C627CE-E4B7-6641-9682-2BB2D46280A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1833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759D336-9BC6-0D49-8562-68C82C72127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FD3F6EE-52DD-4142-BA1A-4E4F70BB1C2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C921E72-6549-2340-A956-72098D54FB1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357C74AA-B72E-854D-92DA-06403BACA918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8AA28E4-9BF3-C746-98D0-F2600DA7EF6B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63F3462-BFDF-B042-A50C-FE33B393D0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B330215-B529-264D-A547-C2B6EED8302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C40BC1A-9E84-4A4F-8A43-D011B12B39F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53730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2C6182F-3CC9-4B4C-9730-0FAE9DBA83F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AF9AFE7-5CCD-AF48-A3C8-BE25CABECAA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4B29A13-7DDF-9940-AB27-768173E543E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3A803E1-34C7-1F47-B21C-1380861EB6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121906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A5694B4-58FA-A540-9873-8C4B104710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0368EFD-1BDE-9144-A3FB-BD7001C5069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ABFE3705-6816-C74A-A3B0-7F924992D1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577408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FB7790-AE76-C74B-AB43-DB72A14876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C21DEC1-C4B3-C24D-B963-DD1A78D38D9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7ABEF2E-F767-7545-9228-A8EDD2CD080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2A7630C-A276-7B4B-BD6C-35C6757C904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A41641E-41D3-F94F-A776-6820FE5A1E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157C581-66C1-C247-B855-366767B969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81212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0B57223-CA86-8440-866F-A41D16B5DD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28E80D4-8E7D-3144-A061-4340AB2AAA1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D1BD8E0-E4DB-EF4E-9DFE-F4823690514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3596388-8AAD-1745-A237-7134D3810FB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0EC3E13-48C8-604B-8473-D2E7A63007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A03E850-989F-8247-8F55-6260259496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2788204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E0934EE-2454-D047-A027-39331923D4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33B943A-364A-884E-9C08-0815B251C8C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57397B-29FD-C34E-9B29-4746A03EAD3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04A450C-2511-7F49-AB09-47284CC42A55}" type="datetimeFigureOut">
              <a:rPr lang="en-US" smtClean="0"/>
              <a:t>7/9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99C3360-8A42-7743-8E78-C02EE0DD151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2470EFB-B41B-6042-9B91-95939C63686F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A3DE533-1CD5-324C-B739-1A3D94F2923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4939468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tiff"/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86EC60BC-211D-394A-BF35-1DF0B142FBC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89246" y="1238853"/>
            <a:ext cx="889000" cy="1816100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FA8B76F4-F2B0-E94A-A8C4-F64D94737DF5}"/>
              </a:ext>
            </a:extLst>
          </p:cNvPr>
          <p:cNvSpPr txBox="1"/>
          <p:nvPr/>
        </p:nvSpPr>
        <p:spPr>
          <a:xfrm>
            <a:off x="572313" y="3186844"/>
            <a:ext cx="13758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 GLU LPS PAN 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36B367B-1CD6-BC40-97FE-F42302DB29DF}"/>
              </a:ext>
            </a:extLst>
          </p:cNvPr>
          <p:cNvSpPr txBox="1"/>
          <p:nvPr/>
        </p:nvSpPr>
        <p:spPr>
          <a:xfrm>
            <a:off x="1479216" y="2420053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63 at 31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5CECECE0-08D8-3849-B666-A8F3F0476E3D}"/>
              </a:ext>
            </a:extLst>
          </p:cNvPr>
          <p:cNvSpPr txBox="1"/>
          <p:nvPr/>
        </p:nvSpPr>
        <p:spPr>
          <a:xfrm>
            <a:off x="1478246" y="2262800"/>
            <a:ext cx="2274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  at 36 </a:t>
            </a:r>
            <a:r>
              <a:rPr lang="en-US" sz="1000" dirty="0" err="1"/>
              <a:t>kDa</a:t>
            </a:r>
            <a:endParaRPr lang="en-US" sz="1000" dirty="0"/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417277AC-7C04-C242-AB63-407999C4AF6F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2676223" y="1166902"/>
            <a:ext cx="1143000" cy="2032000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353969A0-2C8B-3F47-A630-79459311FB49}"/>
              </a:ext>
            </a:extLst>
          </p:cNvPr>
          <p:cNvSpPr txBox="1"/>
          <p:nvPr/>
        </p:nvSpPr>
        <p:spPr>
          <a:xfrm>
            <a:off x="3795414" y="1876896"/>
            <a:ext cx="2274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RP94 at 94 </a:t>
            </a:r>
            <a:r>
              <a:rPr lang="en-US" sz="1000" dirty="0" err="1"/>
              <a:t>kDa</a:t>
            </a:r>
            <a:endParaRPr lang="en-US" sz="1000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7A8ADEB5-A52A-484E-A3D3-69241E1F52E8}"/>
              </a:ext>
            </a:extLst>
          </p:cNvPr>
          <p:cNvSpPr txBox="1"/>
          <p:nvPr/>
        </p:nvSpPr>
        <p:spPr>
          <a:xfrm>
            <a:off x="2812821" y="3186844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 GLU LPS PAN </a:t>
            </a:r>
          </a:p>
        </p:txBody>
      </p:sp>
      <p:pic>
        <p:nvPicPr>
          <p:cNvPr id="11" name="Picture 10">
            <a:extLst>
              <a:ext uri="{FF2B5EF4-FFF2-40B4-BE49-F238E27FC236}">
                <a16:creationId xmlns:a16="http://schemas.microsoft.com/office/drawing/2014/main" id="{0DC2F1FD-B6F8-0E4B-B313-65BE6DF01F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949441" y="1143926"/>
            <a:ext cx="787400" cy="1841500"/>
          </a:xfrm>
          <a:prstGeom prst="rect">
            <a:avLst/>
          </a:prstGeom>
        </p:spPr>
      </p:pic>
      <p:sp>
        <p:nvSpPr>
          <p:cNvPr id="12" name="TextBox 11">
            <a:extLst>
              <a:ext uri="{FF2B5EF4-FFF2-40B4-BE49-F238E27FC236}">
                <a16:creationId xmlns:a16="http://schemas.microsoft.com/office/drawing/2014/main" id="{09434726-834D-A543-8E0F-C705BDB09D7E}"/>
              </a:ext>
            </a:extLst>
          </p:cNvPr>
          <p:cNvSpPr txBox="1"/>
          <p:nvPr/>
        </p:nvSpPr>
        <p:spPr>
          <a:xfrm>
            <a:off x="5736841" y="2563471"/>
            <a:ext cx="2274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SG101 at 45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0C5547A6-02D0-DC40-B442-0E6EAF8878D0}"/>
              </a:ext>
            </a:extLst>
          </p:cNvPr>
          <p:cNvSpPr txBox="1"/>
          <p:nvPr/>
        </p:nvSpPr>
        <p:spPr>
          <a:xfrm>
            <a:off x="4915574" y="3186844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 GLU LPS PAN 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2A7F8C80-3031-6645-A290-AA2A883057CB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656948" y="3847106"/>
            <a:ext cx="749300" cy="2336800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DB79E266-75F9-2147-B6D5-E7FD3AB6F6AF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09097" y="3967756"/>
            <a:ext cx="698500" cy="2095500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5817443-D14E-7C4B-B6B2-E44D1AE0CCB5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4930482" y="3967756"/>
            <a:ext cx="965200" cy="2336800"/>
          </a:xfrm>
          <a:prstGeom prst="rect">
            <a:avLst/>
          </a:prstGeom>
        </p:spPr>
      </p:pic>
      <p:pic>
        <p:nvPicPr>
          <p:cNvPr id="20" name="Picture 19">
            <a:extLst>
              <a:ext uri="{FF2B5EF4-FFF2-40B4-BE49-F238E27FC236}">
                <a16:creationId xmlns:a16="http://schemas.microsoft.com/office/drawing/2014/main" id="{793A8B3E-C7B4-E44B-8CEC-25EFA6BFC981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7218567" y="3967756"/>
            <a:ext cx="1143000" cy="2336800"/>
          </a:xfrm>
          <a:prstGeom prst="rect">
            <a:avLst/>
          </a:prstGeom>
        </p:spPr>
      </p:pic>
      <p:sp>
        <p:nvSpPr>
          <p:cNvPr id="21" name="TextBox 20">
            <a:extLst>
              <a:ext uri="{FF2B5EF4-FFF2-40B4-BE49-F238E27FC236}">
                <a16:creationId xmlns:a16="http://schemas.microsoft.com/office/drawing/2014/main" id="{248A8727-205A-8143-B87D-0C5DAFB5E8E9}"/>
              </a:ext>
            </a:extLst>
          </p:cNvPr>
          <p:cNvSpPr txBox="1"/>
          <p:nvPr/>
        </p:nvSpPr>
        <p:spPr>
          <a:xfrm>
            <a:off x="1353339" y="5214108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CD63 at 31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80C20FCD-0226-4248-943F-DAC5466313C8}"/>
              </a:ext>
            </a:extLst>
          </p:cNvPr>
          <p:cNvSpPr txBox="1"/>
          <p:nvPr/>
        </p:nvSpPr>
        <p:spPr>
          <a:xfrm>
            <a:off x="567584" y="6293853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 GLU LPS PAN 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2E34BBA2-9A4F-9D47-8946-59A9C97E795F}"/>
              </a:ext>
            </a:extLst>
          </p:cNvPr>
          <p:cNvSpPr txBox="1"/>
          <p:nvPr/>
        </p:nvSpPr>
        <p:spPr>
          <a:xfrm>
            <a:off x="3573675" y="5547107"/>
            <a:ext cx="200871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APDH at 36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DDA1F3FF-2BD1-BA46-95A9-A45B293F22B5}"/>
              </a:ext>
            </a:extLst>
          </p:cNvPr>
          <p:cNvSpPr txBox="1"/>
          <p:nvPr/>
        </p:nvSpPr>
        <p:spPr>
          <a:xfrm>
            <a:off x="2711735" y="6293853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AN  LPS GLU S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578D654D-2608-2042-8BB3-EC58A87DF2DA}"/>
              </a:ext>
            </a:extLst>
          </p:cNvPr>
          <p:cNvSpPr txBox="1"/>
          <p:nvPr/>
        </p:nvSpPr>
        <p:spPr>
          <a:xfrm>
            <a:off x="5870236" y="4685183"/>
            <a:ext cx="121484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GRp94 at 94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103A5FCC-1EDB-7A47-BF82-CD91EEE2A2F7}"/>
              </a:ext>
            </a:extLst>
          </p:cNvPr>
          <p:cNvSpPr txBox="1"/>
          <p:nvPr/>
        </p:nvSpPr>
        <p:spPr>
          <a:xfrm>
            <a:off x="4908107" y="6293853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SS GLU LPS PAN 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53F05D6-1CA8-3B46-9C90-0EFC03C9F8B9}"/>
              </a:ext>
            </a:extLst>
          </p:cNvPr>
          <p:cNvSpPr txBox="1"/>
          <p:nvPr/>
        </p:nvSpPr>
        <p:spPr>
          <a:xfrm>
            <a:off x="7283088" y="6293853"/>
            <a:ext cx="1642533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PAN  LPS GLU SS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A07DEE21-2386-884C-B2B3-A823D9A73248}"/>
              </a:ext>
            </a:extLst>
          </p:cNvPr>
          <p:cNvSpPr txBox="1"/>
          <p:nvPr/>
        </p:nvSpPr>
        <p:spPr>
          <a:xfrm>
            <a:off x="8361567" y="5180546"/>
            <a:ext cx="2274188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dirty="0"/>
              <a:t>TSG101 at 45kDa</a:t>
            </a:r>
          </a:p>
        </p:txBody>
      </p:sp>
      <p:sp>
        <p:nvSpPr>
          <p:cNvPr id="33" name="TextBox 23">
            <a:extLst>
              <a:ext uri="{FF2B5EF4-FFF2-40B4-BE49-F238E27FC236}">
                <a16:creationId xmlns:a16="http://schemas.microsoft.com/office/drawing/2014/main" id="{70601DBF-223B-4BE9-8012-E9DAB5EEEC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48333" y="3477455"/>
            <a:ext cx="153150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i="1" dirty="0" err="1">
                <a:latin typeface="Arial" charset="0"/>
                <a:cs typeface="Arial" charset="0"/>
              </a:rPr>
              <a:t>GEnC</a:t>
            </a:r>
            <a:r>
              <a:rPr lang="en-US" sz="1200" b="1" i="1" dirty="0">
                <a:latin typeface="Arial" charset="0"/>
                <a:cs typeface="Arial" charset="0"/>
              </a:rPr>
              <a:t> derived EV </a:t>
            </a:r>
          </a:p>
        </p:txBody>
      </p:sp>
      <p:sp>
        <p:nvSpPr>
          <p:cNvPr id="34" name="TextBox 24">
            <a:extLst>
              <a:ext uri="{FF2B5EF4-FFF2-40B4-BE49-F238E27FC236}">
                <a16:creationId xmlns:a16="http://schemas.microsoft.com/office/drawing/2014/main" id="{6478403A-1E3D-412A-BAD6-C14BE0D5206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94235" y="906014"/>
            <a:ext cx="1226452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=""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2pPr>
            <a:lvl3pPr marL="11430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3pPr>
            <a:lvl4pPr marL="16002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4pPr>
            <a:lvl5pPr marL="2057400" indent="-228600"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Calibri" charset="0"/>
                <a:ea typeface="ＭＳ Ｐゴシック" charset="0"/>
              </a:defRPr>
            </a:lvl9pPr>
          </a:lstStyle>
          <a:p>
            <a:pPr eaLnBrk="1" hangingPunct="1"/>
            <a:r>
              <a:rPr lang="en-US" sz="1200" b="1" i="1" dirty="0" err="1">
                <a:latin typeface="Arial" charset="0"/>
                <a:cs typeface="Arial" charset="0"/>
              </a:rPr>
              <a:t>GEnC</a:t>
            </a:r>
            <a:r>
              <a:rPr lang="en-US" sz="1200" b="1" i="1" dirty="0">
                <a:latin typeface="Arial" charset="0"/>
                <a:cs typeface="Arial" charset="0"/>
              </a:rPr>
              <a:t> alone 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9055BDAC-12AB-434E-A662-EDD4D7B1B68E}"/>
              </a:ext>
            </a:extLst>
          </p:cNvPr>
          <p:cNvSpPr txBox="1"/>
          <p:nvPr/>
        </p:nvSpPr>
        <p:spPr>
          <a:xfrm>
            <a:off x="301841" y="168676"/>
            <a:ext cx="109728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dirty="0"/>
              <a:t>Supplemental Figure – Western blots: UNCROPPED, annotated, full-length images with MW markers</a:t>
            </a:r>
          </a:p>
          <a:p>
            <a:r>
              <a:rPr lang="en-GB" dirty="0"/>
              <a:t>Related to Figure 1h :</a:t>
            </a:r>
          </a:p>
        </p:txBody>
      </p:sp>
    </p:spTree>
    <p:extLst>
      <p:ext uri="{BB962C8B-B14F-4D97-AF65-F5344CB8AC3E}">
        <p14:creationId xmlns:p14="http://schemas.microsoft.com/office/powerpoint/2010/main" val="1959608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80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cola Hill</dc:creator>
  <cp:lastModifiedBy>Woollard, Kevin</cp:lastModifiedBy>
  <cp:revision>3</cp:revision>
  <dcterms:created xsi:type="dcterms:W3CDTF">2019-05-30T19:45:47Z</dcterms:created>
  <dcterms:modified xsi:type="dcterms:W3CDTF">2019-07-09T15:50:11Z</dcterms:modified>
</cp:coreProperties>
</file>